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71E8B-997A-4B24-B784-996E3C6D2A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B7240-82E3-4BB1-A6D7-6223065BFB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5CCF7-4A7B-46B1-9E62-3BA0910249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AE3837-4AD8-469C-943D-69CBDB13FA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3C384-DD95-44A4-8E68-328E616D73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187EB-7D76-4F84-B54B-CC8AB5EDC9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60DC7-F671-4716-8FAD-19BEBA1179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6AD20-C8DC-42C7-9CEA-DE865B5299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2AF66-3A1A-4575-B396-EA068B5332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8E48B-6271-4F73-93AE-9FA8F45FEE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1CE80-FA97-49B6-8B11-2F0EAC36CA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3AF02-EB52-4115-A4DA-778F1A81A3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C426B4-B87C-438F-BD6A-8D2A7C78EF03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22760" y="139680"/>
            <a:ext cx="222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Supplementary Figure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2" name="Chart 5"/>
          <p:cNvGraphicFramePr/>
          <p:nvPr/>
        </p:nvGraphicFramePr>
        <p:xfrm>
          <a:off x="595440" y="639720"/>
          <a:ext cx="5638680" cy="32958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Char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95440" y="639720"/>
                    <a:ext cx="5638680" cy="3295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Box 6"/>
          <p:cNvSpPr/>
          <p:nvPr/>
        </p:nvSpPr>
        <p:spPr>
          <a:xfrm>
            <a:off x="3360600" y="3780000"/>
            <a:ext cx="119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Days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TextBox 7"/>
          <p:cNvSpPr/>
          <p:nvPr/>
        </p:nvSpPr>
        <p:spPr>
          <a:xfrm rot="16200000">
            <a:off x="-279000" y="2020680"/>
            <a:ext cx="18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Body weight gain (g)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627120" y="4213080"/>
            <a:ext cx="5643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upplementary Figure.  Body weight gain in control and diabetic rats.  Rats were fed a chow or high-fat diet for 21 days, with STZ injected at varying doses at day 14.  n = 4 - 11 per group.</a:t>
            </a: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7T14:32:33Z</dcterms:created>
  <dc:creator>Lisa</dc:creator>
  <dc:description/>
  <dc:language>en-US</dc:language>
  <cp:lastModifiedBy>Heather, Lisa C</cp:lastModifiedBy>
  <cp:lastPrinted>2013-09-05T16:33:46Z</cp:lastPrinted>
  <dcterms:modified xsi:type="dcterms:W3CDTF">2013-09-17T11:01:06Z</dcterms:modified>
  <cp:revision>149</cp:revision>
  <dc:subject/>
  <dc:title>Slide 1</dc:title>
</cp:coreProperties>
</file>